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34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96" autoAdjust="0"/>
    <p:restoredTop sz="94660"/>
  </p:normalViewPr>
  <p:slideViewPr>
    <p:cSldViewPr snapToGrid="0" showGuides="1">
      <p:cViewPr varScale="1">
        <p:scale>
          <a:sx n="172" d="100"/>
          <a:sy n="172" d="100"/>
        </p:scale>
        <p:origin x="3336" y="132"/>
      </p:cViewPr>
      <p:guideLst>
        <p:guide orient="horz" pos="1434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DCB049-BF1F-4172-AD14-B62F993BE293}" type="datetimeFigureOut">
              <a:rPr kumimoji="1" lang="ja-JP" altLang="en-US" smtClean="0"/>
              <a:t>2025/1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48930E-7AD7-4828-AB96-DC7C64851D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31957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A48930E-7AD7-4828-AB96-DC7C64851D3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72172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67EC1F1-2335-23E1-C48E-26CAFFC86A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93386FE-87AA-4D24-E1EE-C910A6508A2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F6C9898-018B-4DF7-7B6D-FECD04A37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BC09-7B32-47FC-BC1E-EF2425E5AEF9}" type="datetimeFigureOut">
              <a:rPr kumimoji="1" lang="ja-JP" altLang="en-US" smtClean="0"/>
              <a:t>2025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44C08B3-1DDB-EAFF-2739-D936331A01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AE31931-8643-1587-D9A4-A0E43050E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5BC877-ACE5-4FB2-8983-DC560611DA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0595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B33C11-91FB-D50F-29FE-1CEC8A0D26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DF75CA5-8293-713D-1585-4847DF4E62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BFE2F8E-8268-12CF-7741-1D1844EB3D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BC09-7B32-47FC-BC1E-EF2425E5AEF9}" type="datetimeFigureOut">
              <a:rPr kumimoji="1" lang="ja-JP" altLang="en-US" smtClean="0"/>
              <a:t>2025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33A439D-1775-1301-019A-227AE03EA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9557299-5E66-DF8A-914F-C9286A69DA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5BC877-ACE5-4FB2-8983-DC560611DA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5669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932E8B7-308B-159A-7BA0-A86A2BC4BF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247D733-0F0D-F644-40C5-9030CC235C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5206DE9-0ABA-F37A-7372-6BB9A66AF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BC09-7B32-47FC-BC1E-EF2425E5AEF9}" type="datetimeFigureOut">
              <a:rPr kumimoji="1" lang="ja-JP" altLang="en-US" smtClean="0"/>
              <a:t>2025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E1C80C0-63FF-7582-A2A1-A3259ECE0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BD031AA-35F5-B6D7-31A1-395292470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5BC877-ACE5-4FB2-8983-DC560611DA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1731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932531-A45F-8653-D937-A12D702704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A3EDF3E-43B3-400E-F0DB-48518C1A79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C8480BC-0D72-142B-5FB3-8516C5942E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BC09-7B32-47FC-BC1E-EF2425E5AEF9}" type="datetimeFigureOut">
              <a:rPr kumimoji="1" lang="ja-JP" altLang="en-US" smtClean="0"/>
              <a:t>2025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7E1ABD5-F6CA-09B5-1C6B-B879411F8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B7FF3D7-528F-9CD3-284D-D2B7C4D041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5BC877-ACE5-4FB2-8983-DC560611DA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71915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5F1BE1-B611-060C-1111-8258E1C42E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3ABEE84-4E68-4E8F-46C5-1937E380B3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9B5FFC2-C111-F153-5985-D2CD44D6CA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BC09-7B32-47FC-BC1E-EF2425E5AEF9}" type="datetimeFigureOut">
              <a:rPr kumimoji="1" lang="ja-JP" altLang="en-US" smtClean="0"/>
              <a:t>2025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15D3D6-41C8-0454-DC83-C3680D495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952837-48F2-0B94-8A0C-6262DC860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5BC877-ACE5-4FB2-8983-DC560611DA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5321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05539E-AD25-B4BD-09FD-143EB9CDCC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714FE13-79B6-07AB-44A5-F3C5C6F820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E3F5130-7212-1419-64B2-A91A4F2326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601D057-2F00-8935-082F-5F58E2A811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BC09-7B32-47FC-BC1E-EF2425E5AEF9}" type="datetimeFigureOut">
              <a:rPr kumimoji="1" lang="ja-JP" altLang="en-US" smtClean="0"/>
              <a:t>2025/1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BA5AA21-7959-46BB-9A7F-29577B2E72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A1101B5-44DC-EC7E-E844-D406998AF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5BC877-ACE5-4FB2-8983-DC560611DA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8083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667DEA2-F973-945C-295C-B83ABD2A5D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031DE3D-BAFB-022C-BED1-0DF255B873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48EFB83-19AA-45AE-494F-2C8DFAEA1C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DF30882-28D0-6162-932E-726384452E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C933950-6E44-8AF0-D867-9C7D1EF5D3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4316AF7-BAF2-DFEB-7DE5-0F6FD89E6D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BC09-7B32-47FC-BC1E-EF2425E5AEF9}" type="datetimeFigureOut">
              <a:rPr kumimoji="1" lang="ja-JP" altLang="en-US" smtClean="0"/>
              <a:t>2025/1/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B4C90AC-06DE-0C8C-0D18-3A9967155F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A72E581-2F0F-5BF7-7BBE-4A4BB6CFF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5BC877-ACE5-4FB2-8983-DC560611DA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21698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DA17AC8-2E7D-8FC7-BBD3-9B9D843F8B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0247833-1DC4-3C6E-168B-BEEE69F43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BC09-7B32-47FC-BC1E-EF2425E5AEF9}" type="datetimeFigureOut">
              <a:rPr kumimoji="1" lang="ja-JP" altLang="en-US" smtClean="0"/>
              <a:t>2025/1/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7CC7B9B-691A-A1E9-30D5-C17FEE9EC6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EEDE23C-5963-AD68-3E90-942D363F88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5BC877-ACE5-4FB2-8983-DC560611DA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748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F038313-BA0B-C372-3697-EFFA6B441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BC09-7B32-47FC-BC1E-EF2425E5AEF9}" type="datetimeFigureOut">
              <a:rPr kumimoji="1" lang="ja-JP" altLang="en-US" smtClean="0"/>
              <a:t>2025/1/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D545688-C958-3643-1C47-6FDF85F1BC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5EABD94-A200-0829-C14A-55E3B33A7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5BC877-ACE5-4FB2-8983-DC560611DA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159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8990D73-E419-196D-1B16-88A20FE2B2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45110DF-DAA1-C13E-2805-959EDA6882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512DDA4-DD40-9CE8-02B1-A626DA5150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826573F-DB35-AB50-71C0-5B552E097E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BC09-7B32-47FC-BC1E-EF2425E5AEF9}" type="datetimeFigureOut">
              <a:rPr kumimoji="1" lang="ja-JP" altLang="en-US" smtClean="0"/>
              <a:t>2025/1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42500E9-8D1D-9BB1-2B0D-14157A3BB5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77BA6E5-52D5-25D5-7C00-B6FBCAC9A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5BC877-ACE5-4FB2-8983-DC560611DA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4638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1D6292-89DD-98B7-200A-0827C3B76B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B9B5D95-2E18-BCB6-EA46-9FBA1AF61E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1A9F169-9A09-459B-5DAA-CB74916498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DE71297-1FF6-3586-4EC6-0BEF0EC55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6BC09-7B32-47FC-BC1E-EF2425E5AEF9}" type="datetimeFigureOut">
              <a:rPr kumimoji="1" lang="ja-JP" altLang="en-US" smtClean="0"/>
              <a:t>2025/1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225E4A2-D7CA-A44E-9713-E452DCC829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F4E0DBB-BCE5-DCF3-74D0-B1C087270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5BC877-ACE5-4FB2-8983-DC560611DA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7756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AD9953E-B39D-433F-37E7-55E2AA68A3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DD0F588-7544-C268-961D-D6D4A5F440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26B5C7-E036-097B-B8F7-8E5FA4CA83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A6BC09-7B32-47FC-BC1E-EF2425E5AEF9}" type="datetimeFigureOut">
              <a:rPr kumimoji="1" lang="ja-JP" altLang="en-US" smtClean="0"/>
              <a:t>2025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BEACB79-E4D6-08E7-F3B3-EAEDFFB78B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000523-B3EF-76FD-4B08-35AAD7FCDE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F5BC877-ACE5-4FB2-8983-DC560611DA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2706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四角形: 角を丸くする 43">
            <a:extLst>
              <a:ext uri="{FF2B5EF4-FFF2-40B4-BE49-F238E27FC236}">
                <a16:creationId xmlns:a16="http://schemas.microsoft.com/office/drawing/2014/main" id="{A57CBB0F-2A54-D962-C2B0-F37DC255F56A}"/>
              </a:ext>
            </a:extLst>
          </p:cNvPr>
          <p:cNvSpPr/>
          <p:nvPr/>
        </p:nvSpPr>
        <p:spPr>
          <a:xfrm>
            <a:off x="5819361" y="1567260"/>
            <a:ext cx="6139048" cy="3122377"/>
          </a:xfrm>
          <a:prstGeom prst="roundRect">
            <a:avLst>
              <a:gd name="adj" fmla="val 2470"/>
            </a:avLst>
          </a:prstGeom>
          <a:solidFill>
            <a:schemeClr val="tx2">
              <a:lumMod val="10000"/>
              <a:lumOff val="90000"/>
            </a:schemeClr>
          </a:solidFill>
          <a:ln>
            <a:noFill/>
          </a:ln>
          <a:effectLst>
            <a:innerShdw blurRad="63500" dist="50800" dir="2700000">
              <a:prstClr val="black">
                <a:alpha val="50000"/>
              </a:prstClr>
            </a:inn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accent6">
                  <a:lumMod val="20000"/>
                  <a:lumOff val="8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四角形: 角を丸くする 30">
            <a:extLst>
              <a:ext uri="{FF2B5EF4-FFF2-40B4-BE49-F238E27FC236}">
                <a16:creationId xmlns:a16="http://schemas.microsoft.com/office/drawing/2014/main" id="{1A2EE121-BB94-4CF9-9D61-BAA6996B0EAA}"/>
              </a:ext>
            </a:extLst>
          </p:cNvPr>
          <p:cNvSpPr/>
          <p:nvPr/>
        </p:nvSpPr>
        <p:spPr>
          <a:xfrm>
            <a:off x="5823173" y="4811086"/>
            <a:ext cx="6139048" cy="1265812"/>
          </a:xfrm>
          <a:prstGeom prst="roundRect">
            <a:avLst>
              <a:gd name="adj" fmla="val 5749"/>
            </a:avLst>
          </a:prstGeom>
          <a:solidFill>
            <a:schemeClr val="tx2">
              <a:lumMod val="10000"/>
              <a:lumOff val="90000"/>
            </a:schemeClr>
          </a:solidFill>
          <a:ln>
            <a:noFill/>
          </a:ln>
          <a:effectLst>
            <a:innerShdw blurRad="63500" dist="50800" dir="2700000">
              <a:prstClr val="black">
                <a:alpha val="50000"/>
              </a:prstClr>
            </a:inn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accent6">
                  <a:lumMod val="20000"/>
                  <a:lumOff val="8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四角形: 角を丸くする 28">
            <a:extLst>
              <a:ext uri="{FF2B5EF4-FFF2-40B4-BE49-F238E27FC236}">
                <a16:creationId xmlns:a16="http://schemas.microsoft.com/office/drawing/2014/main" id="{F0413E12-103C-52AE-8328-BF6CC3F83CE0}"/>
              </a:ext>
            </a:extLst>
          </p:cNvPr>
          <p:cNvSpPr/>
          <p:nvPr/>
        </p:nvSpPr>
        <p:spPr>
          <a:xfrm>
            <a:off x="260549" y="1566009"/>
            <a:ext cx="5394541" cy="4510889"/>
          </a:xfrm>
          <a:prstGeom prst="roundRect">
            <a:avLst>
              <a:gd name="adj" fmla="val 2470"/>
            </a:avLst>
          </a:prstGeom>
          <a:solidFill>
            <a:schemeClr val="tx2">
              <a:lumMod val="10000"/>
              <a:lumOff val="90000"/>
            </a:schemeClr>
          </a:solidFill>
          <a:ln>
            <a:noFill/>
          </a:ln>
          <a:effectLst>
            <a:innerShdw blurRad="63500" dist="50800" dir="2700000">
              <a:prstClr val="black">
                <a:alpha val="50000"/>
              </a:prstClr>
            </a:inn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accent6">
                  <a:lumMod val="20000"/>
                  <a:lumOff val="8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四角形: 角を丸くする 44">
            <a:extLst>
              <a:ext uri="{FF2B5EF4-FFF2-40B4-BE49-F238E27FC236}">
                <a16:creationId xmlns:a16="http://schemas.microsoft.com/office/drawing/2014/main" id="{FF0E81D0-4C4F-525A-B63D-B97D5D9054FE}"/>
              </a:ext>
            </a:extLst>
          </p:cNvPr>
          <p:cNvSpPr/>
          <p:nvPr/>
        </p:nvSpPr>
        <p:spPr>
          <a:xfrm>
            <a:off x="260549" y="449774"/>
            <a:ext cx="11707293" cy="978238"/>
          </a:xfrm>
          <a:prstGeom prst="roundRect">
            <a:avLst>
              <a:gd name="adj" fmla="val 13358"/>
            </a:avLst>
          </a:prstGeom>
          <a:solidFill>
            <a:schemeClr val="tx2">
              <a:lumMod val="10000"/>
              <a:lumOff val="90000"/>
            </a:schemeClr>
          </a:solidFill>
          <a:ln>
            <a:noFill/>
          </a:ln>
          <a:effectLst>
            <a:innerShdw blurRad="63500" dist="50800" dir="2700000">
              <a:prstClr val="black">
                <a:alpha val="50000"/>
              </a:prstClr>
            </a:inn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accent6">
                  <a:lumMod val="20000"/>
                  <a:lumOff val="8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C0375D0-C8A8-1CBD-AF21-FDAEA0A397B5}"/>
              </a:ext>
            </a:extLst>
          </p:cNvPr>
          <p:cNvSpPr txBox="1"/>
          <p:nvPr/>
        </p:nvSpPr>
        <p:spPr>
          <a:xfrm>
            <a:off x="321436" y="493628"/>
            <a:ext cx="19078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✔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BACKGROUND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20A14BF-4420-6D4E-560F-8CA1336445E9}"/>
              </a:ext>
            </a:extLst>
          </p:cNvPr>
          <p:cNvSpPr txBox="1"/>
          <p:nvPr/>
        </p:nvSpPr>
        <p:spPr>
          <a:xfrm>
            <a:off x="5805305" y="1614778"/>
            <a:ext cx="13773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✔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5E3D842-520F-F326-A9EE-D8FDDF9A73D1}"/>
              </a:ext>
            </a:extLst>
          </p:cNvPr>
          <p:cNvSpPr txBox="1"/>
          <p:nvPr/>
        </p:nvSpPr>
        <p:spPr>
          <a:xfrm>
            <a:off x="321436" y="1624291"/>
            <a:ext cx="14814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✔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METHOD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5277C12-D98D-2608-001D-FAF2D94498A5}"/>
              </a:ext>
            </a:extLst>
          </p:cNvPr>
          <p:cNvSpPr txBox="1"/>
          <p:nvPr/>
        </p:nvSpPr>
        <p:spPr>
          <a:xfrm>
            <a:off x="6028627" y="5134812"/>
            <a:ext cx="581966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altLang="ja-JP" sz="1600" i="0" dirty="0">
                <a:solidFill>
                  <a:srgbClr val="3C404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 results demonstrated that measuring drilling torque using a novel density measurement drill is a useful direct and objective method for evaluating cancellous bone density. 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827D3A6-34FC-699C-DC9A-FE0AB10E73EE}"/>
              </a:ext>
            </a:extLst>
          </p:cNvPr>
          <p:cNvSpPr txBox="1"/>
          <p:nvPr/>
        </p:nvSpPr>
        <p:spPr>
          <a:xfrm>
            <a:off x="6036895" y="4004930"/>
            <a:ext cx="543159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rtl="0"/>
            <a:r>
              <a:rPr lang="en-US" altLang="ja-JP" sz="1600" i="0" dirty="0">
                <a:solidFill>
                  <a:srgbClr val="3C404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 drilling torque value showed positive correlation with CT value and bone area ratio.</a:t>
            </a:r>
            <a:endParaRPr lang="ja-JP" altLang="ja-JP" sz="16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9719476B-48F9-929C-9357-3F0E6AA7DB53}"/>
              </a:ext>
            </a:extLst>
          </p:cNvPr>
          <p:cNvSpPr txBox="1"/>
          <p:nvPr/>
        </p:nvSpPr>
        <p:spPr>
          <a:xfrm>
            <a:off x="544422" y="781102"/>
            <a:ext cx="10914762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study aimed to examine the usefulness of a novel density measurement drill for evaluating cancellous bone density by examining the correlation between CT-based Misch bone density classification and drilling torque valu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5B89AB5B-6323-5CEC-8D1A-059F513764CF}"/>
              </a:ext>
            </a:extLst>
          </p:cNvPr>
          <p:cNvGrpSpPr/>
          <p:nvPr/>
        </p:nvGrpSpPr>
        <p:grpSpPr>
          <a:xfrm>
            <a:off x="661828" y="4760203"/>
            <a:ext cx="5252866" cy="1088940"/>
            <a:chOff x="747668" y="4998207"/>
            <a:chExt cx="5252866" cy="1088940"/>
          </a:xfrm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DFEAFF95-8120-C284-E73C-A79619E8422C}"/>
                </a:ext>
              </a:extLst>
            </p:cNvPr>
            <p:cNvSpPr txBox="1"/>
            <p:nvPr/>
          </p:nvSpPr>
          <p:spPr>
            <a:xfrm>
              <a:off x="747668" y="5248336"/>
              <a:ext cx="431040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ea typeface="Roboto" panose="02000000000000000000" pitchFamily="2" charset="0"/>
                  <a:cs typeface="Arial" panose="020B0604020202020204" pitchFamily="34" charset="0"/>
                </a:rPr>
                <a:t>2.</a:t>
              </a:r>
              <a:r>
                <a:rPr lang="en-US" altLang="ja-JP" sz="1600" i="0" u="none" strike="noStrike" baseline="0" dirty="0">
                  <a:latin typeface="Arial" panose="020B0604020202020204" pitchFamily="34" charset="0"/>
                  <a:ea typeface="Roboto" panose="02000000000000000000" pitchFamily="2" charset="0"/>
                  <a:cs typeface="Arial" panose="020B0604020202020204" pitchFamily="34" charset="0"/>
                </a:rPr>
                <a:t> </a:t>
              </a:r>
              <a:r>
                <a:rPr lang="en-US" altLang="ja-JP" sz="1600" dirty="0">
                  <a:latin typeface="Arial" panose="020B0604020202020204" pitchFamily="34" charset="0"/>
                  <a:ea typeface="Roboto" panose="02000000000000000000" pitchFamily="2" charset="0"/>
                  <a:cs typeface="Arial" panose="020B0604020202020204" pitchFamily="34" charset="0"/>
                </a:rPr>
                <a:t>Measurement of drilling torque</a:t>
              </a:r>
              <a:endParaRPr kumimoji="1" lang="ja-JP" altLang="en-US" sz="16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2A85CC83-A71D-7309-4CD4-45B628F2AC42}"/>
                </a:ext>
              </a:extLst>
            </p:cNvPr>
            <p:cNvSpPr txBox="1"/>
            <p:nvPr/>
          </p:nvSpPr>
          <p:spPr>
            <a:xfrm>
              <a:off x="747668" y="4998207"/>
              <a:ext cx="5252866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ea typeface="Roboto" panose="02000000000000000000" pitchFamily="2" charset="0"/>
                  <a:cs typeface="Arial" panose="020B0604020202020204" pitchFamily="34" charset="0"/>
                </a:rPr>
                <a:t>1. Multidetector CT scan of bovine</a:t>
              </a:r>
              <a:r>
                <a:rPr lang="ja-JP" altLang="en-US" sz="1600" dirty="0">
                  <a:latin typeface="Arial" panose="020B0604020202020204" pitchFamily="34" charset="0"/>
                  <a:ea typeface="Roboto" panose="02000000000000000000" pitchFamily="2" charset="0"/>
                  <a:cs typeface="Arial" panose="020B0604020202020204" pitchFamily="34" charset="0"/>
                </a:rPr>
                <a:t> </a:t>
              </a:r>
              <a:r>
                <a:rPr lang="en-US" altLang="ja-JP" sz="1600" dirty="0">
                  <a:latin typeface="Arial" panose="020B0604020202020204" pitchFamily="34" charset="0"/>
                  <a:ea typeface="Roboto" panose="02000000000000000000" pitchFamily="2" charset="0"/>
                  <a:cs typeface="Arial" panose="020B0604020202020204" pitchFamily="34" charset="0"/>
                </a:rPr>
                <a:t>bone</a:t>
              </a:r>
              <a:endParaRPr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158F57F9-2CA6-7E2F-F269-C7FDA3BE251E}"/>
                </a:ext>
              </a:extLst>
            </p:cNvPr>
            <p:cNvSpPr txBox="1"/>
            <p:nvPr/>
          </p:nvSpPr>
          <p:spPr>
            <a:xfrm>
              <a:off x="747668" y="5498465"/>
              <a:ext cx="47839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ea typeface="Roboto" panose="02000000000000000000" pitchFamily="2" charset="0"/>
                  <a:cs typeface="Arial" panose="020B0604020202020204" pitchFamily="34" charset="0"/>
                </a:rPr>
                <a:t>3.</a:t>
              </a:r>
              <a:r>
                <a:rPr lang="en-US" altLang="ja-JP" sz="1600" i="0" u="none" strike="noStrike" baseline="0" dirty="0">
                  <a:latin typeface="Arial" panose="020B0604020202020204" pitchFamily="34" charset="0"/>
                  <a:ea typeface="Roboto" panose="02000000000000000000" pitchFamily="2" charset="0"/>
                  <a:cs typeface="Arial" panose="020B0604020202020204" pitchFamily="34" charset="0"/>
                </a:rPr>
                <a:t> </a:t>
              </a:r>
              <a:r>
                <a:rPr lang="en-US" altLang="ja-JP" sz="1600" i="0" u="none" strike="noStrike" baseline="0" dirty="0" err="1">
                  <a:latin typeface="Arial" panose="020B0604020202020204" pitchFamily="34" charset="0"/>
                  <a:ea typeface="Roboto" panose="02000000000000000000" pitchFamily="2" charset="0"/>
                  <a:cs typeface="Arial" panose="020B0604020202020204" pitchFamily="34" charset="0"/>
                </a:rPr>
                <a:t>H</a:t>
              </a:r>
              <a:r>
                <a:rPr lang="en-US" altLang="ja-JP" sz="1600" dirty="0" err="1">
                  <a:effectLst/>
                  <a:latin typeface="Arial" panose="020B0604020202020204" pitchFamily="34" charset="0"/>
                  <a:ea typeface="Roboto" panose="02000000000000000000" pitchFamily="2" charset="0"/>
                  <a:cs typeface="Arial" panose="020B0604020202020204" pitchFamily="34" charset="0"/>
                </a:rPr>
                <a:t>istomorphometric</a:t>
              </a:r>
              <a:r>
                <a:rPr lang="en-US" altLang="ja-JP" sz="1600" dirty="0">
                  <a:effectLst/>
                  <a:latin typeface="Arial" panose="020B0604020202020204" pitchFamily="34" charset="0"/>
                  <a:ea typeface="Roboto" panose="02000000000000000000" pitchFamily="2" charset="0"/>
                  <a:cs typeface="Arial" panose="020B0604020202020204" pitchFamily="34" charset="0"/>
                </a:rPr>
                <a:t> analysis of the drilling site</a:t>
              </a:r>
              <a:endParaRPr kumimoji="1" lang="ja-JP" altLang="en-US" sz="16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08B13E81-7BB2-8D99-A528-09783F2C70A9}"/>
                </a:ext>
              </a:extLst>
            </p:cNvPr>
            <p:cNvSpPr txBox="1"/>
            <p:nvPr/>
          </p:nvSpPr>
          <p:spPr>
            <a:xfrm>
              <a:off x="747668" y="5748593"/>
              <a:ext cx="431040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ea typeface="Roboto" panose="02000000000000000000" pitchFamily="2" charset="0"/>
                  <a:cs typeface="Arial" panose="020B0604020202020204" pitchFamily="34" charset="0"/>
                </a:rPr>
                <a:t>4.</a:t>
              </a:r>
              <a:r>
                <a:rPr lang="en-US" altLang="ja-JP" sz="1600" i="0" u="none" strike="noStrike" baseline="0" dirty="0">
                  <a:latin typeface="Arial" panose="020B0604020202020204" pitchFamily="34" charset="0"/>
                  <a:ea typeface="Roboto" panose="02000000000000000000" pitchFamily="2" charset="0"/>
                  <a:cs typeface="Arial" panose="020B0604020202020204" pitchFamily="34" charset="0"/>
                </a:rPr>
                <a:t> Examine the correlation</a:t>
              </a:r>
              <a:endParaRPr kumimoji="1" lang="ja-JP" altLang="en-US" sz="16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3204F753-1D61-D568-2F3C-4684E97B58E5}"/>
              </a:ext>
            </a:extLst>
          </p:cNvPr>
          <p:cNvSpPr txBox="1"/>
          <p:nvPr/>
        </p:nvSpPr>
        <p:spPr>
          <a:xfrm>
            <a:off x="5819361" y="4859726"/>
            <a:ext cx="18261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✔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CONCLUSION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C3AE23B0-9344-930D-6F39-2321509A81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28628" y="2005727"/>
            <a:ext cx="2795874" cy="202672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8C72015F-E587-770F-25E1-5453F07C070A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1361"/>
          <a:stretch/>
        </p:blipFill>
        <p:spPr>
          <a:xfrm>
            <a:off x="8926398" y="2002001"/>
            <a:ext cx="2795874" cy="2002929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7745BFAE-8446-1E0F-FBC0-E04DAD4CDB78}"/>
              </a:ext>
            </a:extLst>
          </p:cNvPr>
          <p:cNvSpPr/>
          <p:nvPr/>
        </p:nvSpPr>
        <p:spPr>
          <a:xfrm>
            <a:off x="361009" y="2003894"/>
            <a:ext cx="5054393" cy="2656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3663F606-7B52-66D9-F9D6-DF0FB043CFB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439" y="2394929"/>
            <a:ext cx="1473838" cy="1934756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92E8610-C7F3-73DF-33D9-4C6E0D5E1553}"/>
              </a:ext>
            </a:extLst>
          </p:cNvPr>
          <p:cNvSpPr txBox="1"/>
          <p:nvPr/>
        </p:nvSpPr>
        <p:spPr>
          <a:xfrm>
            <a:off x="672261" y="4324456"/>
            <a:ext cx="416020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0" i="0" dirty="0">
                <a:solidFill>
                  <a:srgbClr val="3C404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amining correlation</a:t>
            </a:r>
            <a:r>
              <a:rPr lang="ja-JP" altLang="en-US" sz="1400" b="0" i="0" dirty="0">
                <a:solidFill>
                  <a:srgbClr val="3C404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or cancellous bone density</a:t>
            </a:r>
            <a:endParaRPr lang="en-US" altLang="ja-JP" sz="1400" b="0" i="0" dirty="0">
              <a:solidFill>
                <a:srgbClr val="3C4043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A65698E-E03F-9036-9367-22D14809CF2B}"/>
              </a:ext>
            </a:extLst>
          </p:cNvPr>
          <p:cNvSpPr txBox="1"/>
          <p:nvPr/>
        </p:nvSpPr>
        <p:spPr>
          <a:xfrm>
            <a:off x="3937707" y="2113075"/>
            <a:ext cx="15068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one area ratio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638C857-C20B-F406-D1CA-1E612C4F2A45}"/>
              </a:ext>
            </a:extLst>
          </p:cNvPr>
          <p:cNvSpPr txBox="1"/>
          <p:nvPr/>
        </p:nvSpPr>
        <p:spPr>
          <a:xfrm>
            <a:off x="2007155" y="2087152"/>
            <a:ext cx="17716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rilling torque valu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図 17">
            <a:extLst>
              <a:ext uri="{FF2B5EF4-FFF2-40B4-BE49-F238E27FC236}">
                <a16:creationId xmlns:a16="http://schemas.microsoft.com/office/drawing/2014/main" id="{DCCCC901-741C-0BA2-9E6D-C00D7120AE5C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8691" r="8887" b="2255"/>
          <a:stretch/>
        </p:blipFill>
        <p:spPr>
          <a:xfrm>
            <a:off x="3832585" y="2377721"/>
            <a:ext cx="1465159" cy="1934756"/>
          </a:xfrm>
          <a:prstGeom prst="rect">
            <a:avLst/>
          </a:prstGeom>
        </p:spPr>
      </p:pic>
      <p:sp>
        <p:nvSpPr>
          <p:cNvPr id="19" name="矢印: 左右 18">
            <a:extLst>
              <a:ext uri="{FF2B5EF4-FFF2-40B4-BE49-F238E27FC236}">
                <a16:creationId xmlns:a16="http://schemas.microsoft.com/office/drawing/2014/main" id="{AC40F32A-9F39-59A2-F36F-89520801D357}"/>
              </a:ext>
            </a:extLst>
          </p:cNvPr>
          <p:cNvSpPr/>
          <p:nvPr/>
        </p:nvSpPr>
        <p:spPr>
          <a:xfrm>
            <a:off x="1928554" y="3277219"/>
            <a:ext cx="225105" cy="139593"/>
          </a:xfrm>
          <a:prstGeom prst="left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7D9B246-D53C-AE7C-9F91-4FDB3C392329}"/>
              </a:ext>
            </a:extLst>
          </p:cNvPr>
          <p:cNvSpPr txBox="1"/>
          <p:nvPr/>
        </p:nvSpPr>
        <p:spPr>
          <a:xfrm>
            <a:off x="750725" y="2091646"/>
            <a:ext cx="8975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T valu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矢印: 左右 20">
            <a:extLst>
              <a:ext uri="{FF2B5EF4-FFF2-40B4-BE49-F238E27FC236}">
                <a16:creationId xmlns:a16="http://schemas.microsoft.com/office/drawing/2014/main" id="{2933AC1D-D0D4-6277-E160-86E7EF4B4743}"/>
              </a:ext>
            </a:extLst>
          </p:cNvPr>
          <p:cNvSpPr/>
          <p:nvPr/>
        </p:nvSpPr>
        <p:spPr>
          <a:xfrm>
            <a:off x="3617227" y="3277219"/>
            <a:ext cx="225105" cy="139593"/>
          </a:xfrm>
          <a:prstGeom prst="left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CABF7744-AB6A-3856-CB66-21692458DF1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51848" y="2379878"/>
            <a:ext cx="1463167" cy="19325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7534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6</TotalTime>
  <Words>124</Words>
  <Application>Microsoft Office PowerPoint</Application>
  <PresentationFormat>ワイド画面</PresentationFormat>
  <Paragraphs>1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土井　一矢</dc:creator>
  <cp:lastModifiedBy>土井　一矢</cp:lastModifiedBy>
  <cp:revision>14</cp:revision>
  <dcterms:created xsi:type="dcterms:W3CDTF">2025-01-04T08:15:17Z</dcterms:created>
  <dcterms:modified xsi:type="dcterms:W3CDTF">2025-01-07T10:36:01Z</dcterms:modified>
</cp:coreProperties>
</file>